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2B24243-6574-494B-9025-40BC81FCC1D1}" v="1" dt="2025-08-19T03:59:58.82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73"/>
    <p:restoredTop sz="94681"/>
  </p:normalViewPr>
  <p:slideViewPr>
    <p:cSldViewPr snapToGrid="0">
      <p:cViewPr varScale="1">
        <p:scale>
          <a:sx n="84" d="100"/>
          <a:sy n="84" d="100"/>
        </p:scale>
        <p:origin x="208" y="8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10" Type="http://schemas.openxmlformats.org/officeDocument/2006/relationships/customXml" Target="../customXml/item3.xml"/><Relationship Id="rId4" Type="http://schemas.openxmlformats.org/officeDocument/2006/relationships/viewProps" Target="view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BF2DAC-421B-C993-D5F8-2A210545DB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B1E02B-EBA9-D1FB-2842-2B803C7788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6A725A-731A-BEAF-8BAA-DD71644E89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F972F-787D-F540-B1DF-A02FFE3BA7F7}" type="datetimeFigureOut">
              <a:rPr lang="en-AU" smtClean="0"/>
              <a:t>19/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AB67DE-A851-91E0-882B-AF1BDF38C2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06A82D-C50F-E082-1371-615D68A7CD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88961-4086-DA4B-99CC-D799AFC0C1C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94930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D3EAB9-74A7-9F26-4D46-781A265FEB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6229A1-04D7-1399-06BF-F427E89A2D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04E830-BF51-F5BB-CD14-D1F1663744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F972F-787D-F540-B1DF-A02FFE3BA7F7}" type="datetimeFigureOut">
              <a:rPr lang="en-AU" smtClean="0"/>
              <a:t>19/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96557D-9DA8-CAB3-F22A-52197560D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BC815A-EB63-E282-A257-4F942A5367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88961-4086-DA4B-99CC-D799AFC0C1C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29807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DC9456-300C-BB32-72D7-7A01379360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5CEFF5-6DC6-6770-2437-AF7A23EEAB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B70396-5764-CC51-F232-B84388C59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F972F-787D-F540-B1DF-A02FFE3BA7F7}" type="datetimeFigureOut">
              <a:rPr lang="en-AU" smtClean="0"/>
              <a:t>19/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B258B8-1D3A-BC1B-04D8-5FD85593CC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902AB8-3066-6462-FE92-2DBE94EF5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88961-4086-DA4B-99CC-D799AFC0C1C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3666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E4F415-E986-7507-E449-72BBB68D33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FEA4C6-C035-4529-5BD8-240234101E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DD5D92-347B-BE3C-EA86-C95E0C92A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F972F-787D-F540-B1DF-A02FFE3BA7F7}" type="datetimeFigureOut">
              <a:rPr lang="en-AU" smtClean="0"/>
              <a:t>19/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9C865F-D507-22A2-E69D-C7752AC1F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2A0706-5FCE-AB1D-1486-C2087960D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88961-4086-DA4B-99CC-D799AFC0C1C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46314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AB7428-2951-1BA6-5AD3-FA0E0164C9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47C274-3DA8-A3A8-9874-2C5CFC8C94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CD4FB9-CAE0-62D6-EE29-23FC637351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F972F-787D-F540-B1DF-A02FFE3BA7F7}" type="datetimeFigureOut">
              <a:rPr lang="en-AU" smtClean="0"/>
              <a:t>19/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171D42-D905-B3D1-A384-62695B3BA5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D685D8-48CF-729A-3C1D-44810C7F1F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88961-4086-DA4B-99CC-D799AFC0C1C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95919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1995D3-F094-D7EC-366F-48E389BDAE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20BA5C-8FC0-4265-CCE9-89DD7FC832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44AE73-2190-64FF-6A40-6D484E97D7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7CD1B8-BB27-E21D-7F9E-D10FA290DA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F972F-787D-F540-B1DF-A02FFE3BA7F7}" type="datetimeFigureOut">
              <a:rPr lang="en-AU" smtClean="0"/>
              <a:t>19/8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4082E8-4F20-E461-5621-8BEAFF73D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235E65-DB3C-ABF8-3868-5030490C1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88961-4086-DA4B-99CC-D799AFC0C1C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51852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95322-FE01-ED3F-1F91-2537B44F92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AF85E9-ED49-BA4C-774A-2A07F96FCD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44FD0C-04CD-5984-CA41-8D7C83335B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530E586-BD9E-5D03-8CBC-C97131A783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B1F210-E139-0314-4CF9-9E7CA4EF09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CD27FE6-63F8-A383-A863-320FB9643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F972F-787D-F540-B1DF-A02FFE3BA7F7}" type="datetimeFigureOut">
              <a:rPr lang="en-AU" smtClean="0"/>
              <a:t>19/8/2025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EFBB561-355E-F1E5-F9B5-8A6B34E3E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CBC4CA-29B3-6279-D68F-243767EEE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88961-4086-DA4B-99CC-D799AFC0C1C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95455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23E41B-6229-BD94-FAE9-E898BE9997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C366B04-7CD9-C7C9-89D8-B694443AEE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F972F-787D-F540-B1DF-A02FFE3BA7F7}" type="datetimeFigureOut">
              <a:rPr lang="en-AU" smtClean="0"/>
              <a:t>19/8/2025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D99985-2307-CC4D-7CFF-EBE0898258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8680D67-7AF4-C77A-971C-3171BD877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88961-4086-DA4B-99CC-D799AFC0C1C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58861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4946ADD-6C9C-0802-38E0-30B30B1C8A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F972F-787D-F540-B1DF-A02FFE3BA7F7}" type="datetimeFigureOut">
              <a:rPr lang="en-AU" smtClean="0"/>
              <a:t>19/8/2025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F76D1F6-9947-AE18-C2D9-83A791283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5B9B971-4BEC-6C46-AFCF-0155CDC5F6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88961-4086-DA4B-99CC-D799AFC0C1C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02178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4BD93F-EBCB-DC4E-2F6F-D1BB0B1104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DFDF2D-2321-108D-4E9A-6E4770C828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AEE688-7A77-156B-1A0E-F2AEBAC225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0C46BE-5C2F-232B-9358-134744F4D5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F972F-787D-F540-B1DF-A02FFE3BA7F7}" type="datetimeFigureOut">
              <a:rPr lang="en-AU" smtClean="0"/>
              <a:t>19/8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AA59A1-F296-F48F-3EFA-6725EF0CF6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F76628-9086-B118-2F7E-94E9FF187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88961-4086-DA4B-99CC-D799AFC0C1C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42473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645743-D845-BB5A-0415-392971AFBA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876BBFA-7CF6-F9F9-486C-58953EB2C6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D33463-C607-74F0-C6A6-1C2DA95161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58D9B4-33C8-E1E9-88C2-8B7466EFF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F972F-787D-F540-B1DF-A02FFE3BA7F7}" type="datetimeFigureOut">
              <a:rPr lang="en-AU" smtClean="0"/>
              <a:t>19/8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75133B-C7FB-8220-AC58-17BA00A12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D0F6C2-22FD-70CB-FB7B-BB01AFFF3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88961-4086-DA4B-99CC-D799AFC0C1C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67766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306A4F-BEE4-1946-1F0A-FF262895B3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802872-A7B2-604B-B466-A10A3D6511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374617-7D7D-DE7A-0FDA-60420617AC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8DF972F-787D-F540-B1DF-A02FFE3BA7F7}" type="datetimeFigureOut">
              <a:rPr lang="en-AU" smtClean="0"/>
              <a:t>19/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724B6B-8F1B-6300-DBCD-0E726A0384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C7007D-097E-F440-863E-D193300854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5188961-4086-DA4B-99CC-D799AFC0C1C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02452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6538B46-7D2D-1A2C-94CC-BFDF61441D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4669" y="1377171"/>
            <a:ext cx="4867055" cy="404906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DD5DB63-5485-73C5-DA35-DC3CA635FF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72417" y="1391026"/>
            <a:ext cx="4867055" cy="404906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BB6B09F-0511-584F-1447-3F719C1D9FC1}"/>
              </a:ext>
            </a:extLst>
          </p:cNvPr>
          <p:cNvSpPr txBox="1"/>
          <p:nvPr/>
        </p:nvSpPr>
        <p:spPr>
          <a:xfrm rot="19380413">
            <a:off x="2472712" y="1210710"/>
            <a:ext cx="14882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RPE </a:t>
            </a:r>
            <a:r>
              <a:rPr lang="en-AU" i="1" dirty="0"/>
              <a:t>BRCA1</a:t>
            </a:r>
            <a:r>
              <a:rPr lang="en-AU" i="1" baseline="30000" dirty="0"/>
              <a:t>-</a:t>
            </a:r>
            <a:r>
              <a:rPr lang="en-AU" baseline="30000" dirty="0"/>
              <a:t>/-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7CA599-E8CE-550D-4203-2C18CE9C7F03}"/>
              </a:ext>
            </a:extLst>
          </p:cNvPr>
          <p:cNvSpPr txBox="1"/>
          <p:nvPr/>
        </p:nvSpPr>
        <p:spPr>
          <a:xfrm rot="19380413">
            <a:off x="2051929" y="1202030"/>
            <a:ext cx="1517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RPE </a:t>
            </a:r>
            <a:r>
              <a:rPr lang="en-AU" i="1" dirty="0"/>
              <a:t>BRCA1</a:t>
            </a:r>
            <a:r>
              <a:rPr lang="en-AU" i="1" baseline="30000" dirty="0"/>
              <a:t>+</a:t>
            </a:r>
            <a:r>
              <a:rPr lang="en-AU" baseline="30000" dirty="0"/>
              <a:t>/-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AA7ADA0-873E-9619-0EE5-768D77376E23}"/>
              </a:ext>
            </a:extLst>
          </p:cNvPr>
          <p:cNvSpPr txBox="1"/>
          <p:nvPr/>
        </p:nvSpPr>
        <p:spPr>
          <a:xfrm rot="19380413">
            <a:off x="2868099" y="1296657"/>
            <a:ext cx="1264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M149PT</a:t>
            </a:r>
            <a:endParaRPr lang="en-AU" baseline="30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6E5BB78-1742-FCDB-0D60-9313EA4DD103}"/>
              </a:ext>
            </a:extLst>
          </p:cNvPr>
          <p:cNvSpPr txBox="1"/>
          <p:nvPr/>
        </p:nvSpPr>
        <p:spPr>
          <a:xfrm rot="19380413">
            <a:off x="3185720" y="1232605"/>
            <a:ext cx="14732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M149.A22</a:t>
            </a:r>
            <a:endParaRPr lang="en-AU" baseline="300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7E08BC0-A01F-082D-C3E0-0906762C8F74}"/>
              </a:ext>
            </a:extLst>
          </p:cNvPr>
          <p:cNvSpPr txBox="1"/>
          <p:nvPr/>
        </p:nvSpPr>
        <p:spPr>
          <a:xfrm rot="19380413">
            <a:off x="3514596" y="1190686"/>
            <a:ext cx="1614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M149 B1.s*</a:t>
            </a:r>
            <a:endParaRPr lang="en-AU" baseline="300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3E95D32-C47E-53F8-2CB2-D040C07236A9}"/>
              </a:ext>
            </a:extLst>
          </p:cNvPr>
          <p:cNvSpPr txBox="1"/>
          <p:nvPr/>
        </p:nvSpPr>
        <p:spPr>
          <a:xfrm rot="19380413">
            <a:off x="3803096" y="1145718"/>
            <a:ext cx="1762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M149 SHLD1</a:t>
            </a:r>
            <a:endParaRPr lang="en-AU" baseline="30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4031FF0-5F02-8AA1-B139-5E51E2D4B2C8}"/>
              </a:ext>
            </a:extLst>
          </p:cNvPr>
          <p:cNvSpPr txBox="1"/>
          <p:nvPr/>
        </p:nvSpPr>
        <p:spPr>
          <a:xfrm rot="19380413">
            <a:off x="4147212" y="1160496"/>
            <a:ext cx="1713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M149 53BP1</a:t>
            </a:r>
            <a:endParaRPr lang="en-AU" baseline="300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52E65F6-0AF0-7208-CE31-B839EF147660}"/>
              </a:ext>
            </a:extLst>
          </p:cNvPr>
          <p:cNvSpPr txBox="1"/>
          <p:nvPr/>
        </p:nvSpPr>
        <p:spPr>
          <a:xfrm>
            <a:off x="1343891" y="2604654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250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6E90319-04B6-2CB7-72C8-EF19D7F508E9}"/>
              </a:ext>
            </a:extLst>
          </p:cNvPr>
          <p:cNvSpPr txBox="1"/>
          <p:nvPr/>
        </p:nvSpPr>
        <p:spPr>
          <a:xfrm>
            <a:off x="1326234" y="3114219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150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C7D43AF-3ABE-E5C8-9B96-31B67DE534E4}"/>
              </a:ext>
            </a:extLst>
          </p:cNvPr>
          <p:cNvSpPr txBox="1"/>
          <p:nvPr/>
        </p:nvSpPr>
        <p:spPr>
          <a:xfrm>
            <a:off x="1310577" y="3606922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100-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852C587-654D-BD07-FA3A-5B265A9B9DBD}"/>
              </a:ext>
            </a:extLst>
          </p:cNvPr>
          <p:cNvSpPr txBox="1"/>
          <p:nvPr/>
        </p:nvSpPr>
        <p:spPr>
          <a:xfrm>
            <a:off x="1435272" y="3875197"/>
            <a:ext cx="5100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75-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BF9194E-0E4F-DBCC-2176-61D58408DDAB}"/>
              </a:ext>
            </a:extLst>
          </p:cNvPr>
          <p:cNvSpPr txBox="1"/>
          <p:nvPr/>
        </p:nvSpPr>
        <p:spPr>
          <a:xfrm>
            <a:off x="1430206" y="4484084"/>
            <a:ext cx="5100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50-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51D2A37-D63D-A0C8-DDC5-3DD4D8FD2DD7}"/>
              </a:ext>
            </a:extLst>
          </p:cNvPr>
          <p:cNvSpPr txBox="1"/>
          <p:nvPr/>
        </p:nvSpPr>
        <p:spPr>
          <a:xfrm>
            <a:off x="1449665" y="4812750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37 -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5A1E5B3-2636-B99D-C2CE-D03DD5D70D4A}"/>
              </a:ext>
            </a:extLst>
          </p:cNvPr>
          <p:cNvSpPr txBox="1"/>
          <p:nvPr/>
        </p:nvSpPr>
        <p:spPr>
          <a:xfrm>
            <a:off x="6465509" y="2563089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250-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8BE8F77-70C0-0872-BD45-79BA8CEB5CC1}"/>
              </a:ext>
            </a:extLst>
          </p:cNvPr>
          <p:cNvSpPr txBox="1"/>
          <p:nvPr/>
        </p:nvSpPr>
        <p:spPr>
          <a:xfrm>
            <a:off x="6447852" y="3072654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150-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18DAED4-8190-620A-B167-050E07F9021C}"/>
              </a:ext>
            </a:extLst>
          </p:cNvPr>
          <p:cNvSpPr txBox="1"/>
          <p:nvPr/>
        </p:nvSpPr>
        <p:spPr>
          <a:xfrm>
            <a:off x="6432195" y="3565357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100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5B87E24-A2A2-75A1-5C78-E21E1D2FA97C}"/>
              </a:ext>
            </a:extLst>
          </p:cNvPr>
          <p:cNvSpPr txBox="1"/>
          <p:nvPr/>
        </p:nvSpPr>
        <p:spPr>
          <a:xfrm>
            <a:off x="6556890" y="3833632"/>
            <a:ext cx="5100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75-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BCD11DD-C022-6FB6-2484-41E711EDB6C8}"/>
              </a:ext>
            </a:extLst>
          </p:cNvPr>
          <p:cNvSpPr txBox="1"/>
          <p:nvPr/>
        </p:nvSpPr>
        <p:spPr>
          <a:xfrm>
            <a:off x="6551824" y="4442519"/>
            <a:ext cx="5100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50-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8FD1518-10FE-07B9-B497-80F3969F9149}"/>
              </a:ext>
            </a:extLst>
          </p:cNvPr>
          <p:cNvSpPr txBox="1"/>
          <p:nvPr/>
        </p:nvSpPr>
        <p:spPr>
          <a:xfrm>
            <a:off x="6571283" y="4771185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37 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DD3C656-6CE9-B796-A10D-07F12DAF9702}"/>
              </a:ext>
            </a:extLst>
          </p:cNvPr>
          <p:cNvSpPr txBox="1"/>
          <p:nvPr/>
        </p:nvSpPr>
        <p:spPr>
          <a:xfrm rot="19380413">
            <a:off x="7543473" y="1363110"/>
            <a:ext cx="14882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RPE </a:t>
            </a:r>
            <a:r>
              <a:rPr lang="en-AU" i="1" dirty="0"/>
              <a:t>BRCA1</a:t>
            </a:r>
            <a:r>
              <a:rPr lang="en-AU" i="1" baseline="30000" dirty="0"/>
              <a:t>-</a:t>
            </a:r>
            <a:r>
              <a:rPr lang="en-AU" baseline="30000" dirty="0"/>
              <a:t>/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07C967B-06D9-69D1-5935-0D37E948B09D}"/>
              </a:ext>
            </a:extLst>
          </p:cNvPr>
          <p:cNvSpPr txBox="1"/>
          <p:nvPr/>
        </p:nvSpPr>
        <p:spPr>
          <a:xfrm rot="19380413">
            <a:off x="7122690" y="1354430"/>
            <a:ext cx="1517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RPE </a:t>
            </a:r>
            <a:r>
              <a:rPr lang="en-AU" i="1" dirty="0"/>
              <a:t>BRCA1</a:t>
            </a:r>
            <a:r>
              <a:rPr lang="en-AU" i="1" baseline="30000" dirty="0"/>
              <a:t>+</a:t>
            </a:r>
            <a:r>
              <a:rPr lang="en-AU" baseline="30000" dirty="0"/>
              <a:t>/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E842A51-F730-77AA-5E2B-ED0533CB5D65}"/>
              </a:ext>
            </a:extLst>
          </p:cNvPr>
          <p:cNvSpPr txBox="1"/>
          <p:nvPr/>
        </p:nvSpPr>
        <p:spPr>
          <a:xfrm rot="19380413">
            <a:off x="7938860" y="1449057"/>
            <a:ext cx="1264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M149PT</a:t>
            </a:r>
            <a:endParaRPr lang="en-AU" baseline="300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2AFBD00-6D79-7BD2-89E7-4D979BC3A782}"/>
              </a:ext>
            </a:extLst>
          </p:cNvPr>
          <p:cNvSpPr txBox="1"/>
          <p:nvPr/>
        </p:nvSpPr>
        <p:spPr>
          <a:xfrm rot="19380413">
            <a:off x="8256481" y="1385005"/>
            <a:ext cx="14732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M149.A22</a:t>
            </a:r>
            <a:endParaRPr lang="en-AU" baseline="300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8611260-AE96-DD77-D082-914BB157B389}"/>
              </a:ext>
            </a:extLst>
          </p:cNvPr>
          <p:cNvSpPr txBox="1"/>
          <p:nvPr/>
        </p:nvSpPr>
        <p:spPr>
          <a:xfrm rot="19380413">
            <a:off x="8585357" y="1343086"/>
            <a:ext cx="1614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M149 B1.s*</a:t>
            </a:r>
            <a:endParaRPr lang="en-AU" baseline="300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DFEDBEE-3880-2C85-D28C-7B35852B00E1}"/>
              </a:ext>
            </a:extLst>
          </p:cNvPr>
          <p:cNvSpPr txBox="1"/>
          <p:nvPr/>
        </p:nvSpPr>
        <p:spPr>
          <a:xfrm rot="19380413">
            <a:off x="8873857" y="1298118"/>
            <a:ext cx="1762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M149 SHLD1</a:t>
            </a:r>
            <a:endParaRPr lang="en-AU" baseline="300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AF7EB56-F402-DA8C-FF0A-2B1FBFDACC87}"/>
              </a:ext>
            </a:extLst>
          </p:cNvPr>
          <p:cNvSpPr txBox="1"/>
          <p:nvPr/>
        </p:nvSpPr>
        <p:spPr>
          <a:xfrm rot="19380413">
            <a:off x="9217973" y="1312896"/>
            <a:ext cx="1713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M149 53BP1</a:t>
            </a:r>
            <a:endParaRPr lang="en-AU" baseline="300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FF4DDAE-4D0C-6FEF-E441-492A17B61154}"/>
              </a:ext>
            </a:extLst>
          </p:cNvPr>
          <p:cNvSpPr txBox="1"/>
          <p:nvPr/>
        </p:nvSpPr>
        <p:spPr>
          <a:xfrm>
            <a:off x="7952509" y="5486400"/>
            <a:ext cx="1350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Anti-BRCA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1F5F6C7-08C9-E531-7157-2B32268A3466}"/>
              </a:ext>
            </a:extLst>
          </p:cNvPr>
          <p:cNvSpPr txBox="1"/>
          <p:nvPr/>
        </p:nvSpPr>
        <p:spPr>
          <a:xfrm>
            <a:off x="2890637" y="5347854"/>
            <a:ext cx="1950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Total protein stain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4413B90-2D35-33AC-ACFE-81990E915877}"/>
              </a:ext>
            </a:extLst>
          </p:cNvPr>
          <p:cNvSpPr txBox="1"/>
          <p:nvPr/>
        </p:nvSpPr>
        <p:spPr>
          <a:xfrm>
            <a:off x="1112520" y="320040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3 Figure</a:t>
            </a:r>
          </a:p>
        </p:txBody>
      </p:sp>
    </p:spTree>
    <p:extLst>
      <p:ext uri="{BB962C8B-B14F-4D97-AF65-F5344CB8AC3E}">
        <p14:creationId xmlns:p14="http://schemas.microsoft.com/office/powerpoint/2010/main" val="316975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AC84E42A7AA71439AD4C9E04C9F06DA" ma:contentTypeVersion="18" ma:contentTypeDescription="Create a new document." ma:contentTypeScope="" ma:versionID="f7887731d8b5c16b1389ad2dda8ad93c">
  <xsd:schema xmlns:xsd="http://www.w3.org/2001/XMLSchema" xmlns:xs="http://www.w3.org/2001/XMLSchema" xmlns:p="http://schemas.microsoft.com/office/2006/metadata/properties" xmlns:ns2="a007d603-003e-46aa-a84a-08e500d7fbd4" xmlns:ns3="949b6590-f457-4a5f-9a1b-b43b8fea004e" targetNamespace="http://schemas.microsoft.com/office/2006/metadata/properties" ma:root="true" ma:fieldsID="5735f07aec2b790cc1dda80670f5e98b" ns2:_="" ns3:_="">
    <xsd:import namespace="a007d603-003e-46aa-a84a-08e500d7fbd4"/>
    <xsd:import namespace="949b6590-f457-4a5f-9a1b-b43b8fea004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3:SharedWithUsers" minOccurs="0"/>
                <xsd:element ref="ns3:SharedWithDetails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SearchPropertie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007d603-003e-46aa-a84a-08e500d7fbd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f2845599-1182-49e5-8f5a-719a1ca1d38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Location" ma:index="25" nillable="true" ma:displayName="Location" ma:description="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49b6590-f457-4a5f-9a1b-b43b8fea004e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81b6c36d-5634-4d26-887d-328ede37b6ce}" ma:internalName="TaxCatchAll" ma:showField="CatchAllData" ma:web="949b6590-f457-4a5f-9a1b-b43b8fea004e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a007d603-003e-46aa-a84a-08e500d7fbd4">
      <Terms xmlns="http://schemas.microsoft.com/office/infopath/2007/PartnerControls"/>
    </lcf76f155ced4ddcb4097134ff3c332f>
    <TaxCatchAll xmlns="949b6590-f457-4a5f-9a1b-b43b8fea004e" xsi:nil="true"/>
  </documentManagement>
</p:properties>
</file>

<file path=customXml/itemProps1.xml><?xml version="1.0" encoding="utf-8"?>
<ds:datastoreItem xmlns:ds="http://schemas.openxmlformats.org/officeDocument/2006/customXml" ds:itemID="{2B717C38-5E22-47CF-B571-138198DEE37C}"/>
</file>

<file path=customXml/itemProps2.xml><?xml version="1.0" encoding="utf-8"?>
<ds:datastoreItem xmlns:ds="http://schemas.openxmlformats.org/officeDocument/2006/customXml" ds:itemID="{99216869-5E69-4723-A56C-FA707BDF380B}"/>
</file>

<file path=customXml/itemProps3.xml><?xml version="1.0" encoding="utf-8"?>
<ds:datastoreItem xmlns:ds="http://schemas.openxmlformats.org/officeDocument/2006/customXml" ds:itemID="{7CA35111-0C37-480D-B271-C28D657C5598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Macintosh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hael Sharp</dc:creator>
  <cp:lastModifiedBy>Michael Sharp</cp:lastModifiedBy>
  <cp:revision>1</cp:revision>
  <dcterms:created xsi:type="dcterms:W3CDTF">2025-08-19T03:59:23Z</dcterms:created>
  <dcterms:modified xsi:type="dcterms:W3CDTF">2025-08-19T04:00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AC84E42A7AA71439AD4C9E04C9F06DA</vt:lpwstr>
  </property>
</Properties>
</file>